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ripl\Desktop\&#55137;&#50672;\0719\PAF&#50836;&#51064;&#48324;&#44536;&#47548;&#44536;&#47532;&#44592;_SMK_Soseul_240624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921025838556916"/>
          <c:y val="0.1180523261608909"/>
          <c:w val="0.78157948322886162"/>
          <c:h val="0.76389534767821821"/>
        </c:manualLayout>
      </c:layout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3D50-41E3-9906-60C20582B8E3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3D50-41E3-9906-60C20582B8E3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3D50-41E3-9906-60C20582B8E3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3D50-41E3-9906-60C20582B8E3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3D50-41E3-9906-60C20582B8E3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3D50-41E3-9906-60C20582B8E3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3D50-41E3-9906-60C20582B8E3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3D50-41E3-9906-60C20582B8E3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3D50-41E3-9906-60C20582B8E3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3D50-41E3-9906-60C20582B8E3}"/>
              </c:ext>
            </c:extLst>
          </c:dPt>
          <c:dPt>
            <c:idx val="10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3D50-41E3-9906-60C20582B8E3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9A358069-5A98-4D36-8568-3DB055DCD609}" type="VALU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값]</a:t>
                    </a:fld>
                    <a:r>
                      <a:rPr lang="en-US" altLang="ko-KR" baseline="0"/>
                      <a:t>%</a:t>
                    </a:r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3D50-41E3-9906-60C20582B8E3}"/>
                </c:ext>
              </c:extLst>
            </c:dLbl>
            <c:dLbl>
              <c:idx val="1"/>
              <c:layout>
                <c:manualLayout>
                  <c:x val="-8.7135623919381108E-2"/>
                  <c:y val="-2.0045104589903461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3D50-41E3-9906-60C20582B8E3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3D50-41E3-9906-60C20582B8E3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3D50-41E3-9906-60C20582B8E3}"/>
                </c:ext>
              </c:extLst>
            </c:dLbl>
            <c:dLbl>
              <c:idx val="4"/>
              <c:layout>
                <c:manualLayout>
                  <c:x val="-2.2245584961421896E-2"/>
                  <c:y val="6.6827644232776151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3D50-41E3-9906-60C20582B8E3}"/>
                </c:ext>
              </c:extLst>
            </c:dLbl>
            <c:dLbl>
              <c:idx val="5"/>
              <c:layout>
                <c:manualLayout>
                  <c:x val="-3.0810571717380542E-2"/>
                  <c:y val="1.413632694331766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037546873502955"/>
                      <c:h val="8.330891945773748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3D50-41E3-9906-60C20582B8E3}"/>
                </c:ext>
              </c:extLst>
            </c:dLbl>
            <c:dLbl>
              <c:idx val="6"/>
              <c:layout>
                <c:manualLayout>
                  <c:x val="-1.1347605945372468E-2"/>
                  <c:y val="-3.879940408377881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3D50-41E3-9906-60C20582B8E3}"/>
                </c:ext>
              </c:extLst>
            </c:dLbl>
            <c:dLbl>
              <c:idx val="7"/>
              <c:layout>
                <c:manualLayout>
                  <c:x val="5.0061138244655294E-2"/>
                  <c:y val="-2.6303267973856209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4881486764414298"/>
                      <c:h val="8.9409633978909234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3D50-41E3-9906-60C20582B8E3}"/>
                </c:ext>
              </c:extLst>
            </c:dLbl>
            <c:dLbl>
              <c:idx val="8"/>
              <c:layout>
                <c:manualLayout>
                  <c:x val="0.18806221021190914"/>
                  <c:y val="1.6339869281045752E-7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9853418676103721"/>
                      <c:h val="0.11199106125668215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1-3D50-41E3-9906-60C20582B8E3}"/>
                </c:ext>
              </c:extLst>
            </c:dLbl>
            <c:dLbl>
              <c:idx val="9"/>
              <c:layout>
                <c:manualLayout>
                  <c:x val="0.28939805661632173"/>
                  <c:y val="1.750081699346405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9265451658991367"/>
                      <c:h val="0.11660784313725488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3D50-41E3-9906-60C20582B8E3}"/>
                </c:ext>
              </c:extLst>
            </c:dLbl>
            <c:dLbl>
              <c:idx val="10"/>
              <c:layout>
                <c:manualLayout>
                  <c:x val="0.35725264756853015"/>
                  <c:y val="5.626633986928103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3D50-41E3-9906-60C20582B8E3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15_I!$A$5:$A$15</c:f>
              <c:strCache>
                <c:ptCount val="11"/>
                <c:pt idx="0">
                  <c:v>Lung</c:v>
                </c:pt>
                <c:pt idx="1">
                  <c:v>Stomach</c:v>
                </c:pt>
                <c:pt idx="2">
                  <c:v>Colorectal</c:v>
                </c:pt>
                <c:pt idx="3">
                  <c:v>Liver</c:v>
                </c:pt>
                <c:pt idx="4">
                  <c:v>Bladder</c:v>
                </c:pt>
                <c:pt idx="5">
                  <c:v>Pancreas</c:v>
                </c:pt>
                <c:pt idx="6">
                  <c:v>Esophagus</c:v>
                </c:pt>
                <c:pt idx="7">
                  <c:v>Larynx</c:v>
                </c:pt>
                <c:pt idx="8">
                  <c:v>Oral cavity/Pharynx</c:v>
                </c:pt>
                <c:pt idx="9">
                  <c:v>Kidney</c:v>
                </c:pt>
                <c:pt idx="10">
                  <c:v>Cervix uteri</c:v>
                </c:pt>
              </c:strCache>
            </c:strRef>
          </c:cat>
          <c:val>
            <c:numRef>
              <c:f>남녀_2015_I!$B$5:$B$15</c:f>
              <c:numCache>
                <c:formatCode>General</c:formatCode>
                <c:ptCount val="11"/>
                <c:pt idx="0">
                  <c:v>42.5</c:v>
                </c:pt>
                <c:pt idx="1">
                  <c:v>23.6</c:v>
                </c:pt>
                <c:pt idx="2">
                  <c:v>9.8000000000000007</c:v>
                </c:pt>
                <c:pt idx="3">
                  <c:v>9</c:v>
                </c:pt>
                <c:pt idx="4">
                  <c:v>4.3</c:v>
                </c:pt>
                <c:pt idx="5">
                  <c:v>3.4</c:v>
                </c:pt>
                <c:pt idx="6">
                  <c:v>2.2999999999999998</c:v>
                </c:pt>
                <c:pt idx="7">
                  <c:v>2.1</c:v>
                </c:pt>
                <c:pt idx="8">
                  <c:v>2</c:v>
                </c:pt>
                <c:pt idx="9">
                  <c:v>0.7</c:v>
                </c:pt>
                <c:pt idx="10">
                  <c:v>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3D50-41E3-9906-60C20582B8E3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5322-47CA-9745-EE07E83243A0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5322-47CA-9745-EE07E83243A0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5322-47CA-9745-EE07E83243A0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5322-47CA-9745-EE07E83243A0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녀_2015_I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녀_2015_I!$B$1:$B$2</c:f>
              <c:numCache>
                <c:formatCode>General</c:formatCode>
                <c:ptCount val="2"/>
                <c:pt idx="0">
                  <c:v>85.7</c:v>
                </c:pt>
                <c:pt idx="1">
                  <c:v>14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322-47CA-9745-EE07E83243A0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116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83B1-4BD1-8FD1-8B16CD05C1D0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83B1-4BD1-8FD1-8B16CD05C1D0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b="1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83B1-4BD1-8FD1-8B16CD05C1D0}"/>
                </c:ext>
              </c:extLst>
            </c:dLbl>
            <c:dLbl>
              <c:idx val="1"/>
              <c:tx>
                <c:rich>
                  <a:bodyPr rot="0" spcFirstLastPara="1" vertOverflow="ellipsis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b="1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83B1-4BD1-8FD1-8B16CD05C1D0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prstDash val="solid"/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15_I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남자_2015_I!$B$1:$B$2</c:f>
              <c:numCache>
                <c:formatCode>General</c:formatCode>
                <c:ptCount val="2"/>
                <c:pt idx="0">
                  <c:v>74.2</c:v>
                </c:pt>
                <c:pt idx="1">
                  <c:v>25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3B1-4BD1-8FD1-8B16CD05C1D0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136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19FC-4396-8BCF-77A4EEB2E7AC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19FC-4396-8BCF-77A4EEB2E7AC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19FC-4396-8BCF-77A4EEB2E7AC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19FC-4396-8BCF-77A4EEB2E7AC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19FC-4396-8BCF-77A4EEB2E7AC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19FC-4396-8BCF-77A4EEB2E7AC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19FC-4396-8BCF-77A4EEB2E7AC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19FC-4396-8BCF-77A4EEB2E7AC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19FC-4396-8BCF-77A4EEB2E7AC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19FC-4396-8BCF-77A4EEB2E7AC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9A358069-5A98-4D36-8568-3DB055DCD609}" type="VALU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값]</a:t>
                    </a:fld>
                    <a:r>
                      <a:rPr lang="en-US" altLang="ko-KR" baseline="0"/>
                      <a:t>%</a:t>
                    </a:r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19FC-4396-8BCF-77A4EEB2E7AC}"/>
                </c:ext>
              </c:extLst>
            </c:dLbl>
            <c:dLbl>
              <c:idx val="1"/>
              <c:layout>
                <c:manualLayout>
                  <c:x val="-7.8528895150521541E-2"/>
                  <c:y val="-5.0966666666666667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19FC-4396-8BCF-77A4EEB2E7AC}"/>
                </c:ext>
              </c:extLst>
            </c:dLbl>
            <c:dLbl>
              <c:idx val="2"/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6="http://schemas.microsoft.com/office/drawing/2014/chart" uri="{C3380CC4-5D6E-409C-BE32-E72D297353CC}">
                  <c16:uniqueId val="{00000005-19FC-4396-8BCF-77A4EEB2E7AC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19FC-4396-8BCF-77A4EEB2E7AC}"/>
                </c:ext>
              </c:extLst>
            </c:dLbl>
            <c:dLbl>
              <c:idx val="4"/>
              <c:layout>
                <c:manualLayout>
                  <c:x val="-2.2245450587018017E-2"/>
                  <c:y val="1.5776178953137997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19FC-4396-8BCF-77A4EEB2E7AC}"/>
                </c:ext>
              </c:extLst>
            </c:dLbl>
            <c:dLbl>
              <c:idx val="5"/>
              <c:layout>
                <c:manualLayout>
                  <c:x val="-3.5072667890516329E-2"/>
                  <c:y val="-5.331919384820652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037546873502955"/>
                      <c:h val="8.330891945773748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19FC-4396-8BCF-77A4EEB2E7AC}"/>
                </c:ext>
              </c:extLst>
            </c:dLbl>
            <c:dLbl>
              <c:idx val="6"/>
              <c:layout>
                <c:manualLayout>
                  <c:x val="-2.681713331385639E-3"/>
                  <c:y val="-3.1931173932987549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19FC-4396-8BCF-77A4EEB2E7AC}"/>
                </c:ext>
              </c:extLst>
            </c:dLbl>
            <c:dLbl>
              <c:idx val="7"/>
              <c:layout>
                <c:manualLayout>
                  <c:x val="5.2389994665354621E-2"/>
                  <c:y val="-1.60426470588235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7040682353287223"/>
                      <c:h val="8.9409647919923826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19FC-4396-8BCF-77A4EEB2E7AC}"/>
                </c:ext>
              </c:extLst>
            </c:dLbl>
            <c:dLbl>
              <c:idx val="8"/>
              <c:layout>
                <c:manualLayout>
                  <c:x val="0.18571718892265565"/>
                  <c:y val="3.3789215686274511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934081698957538"/>
                      <c:h val="9.5969281045751614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1-19FC-4396-8BCF-77A4EEB2E7AC}"/>
                </c:ext>
              </c:extLst>
            </c:dLbl>
            <c:dLbl>
              <c:idx val="9"/>
              <c:layout>
                <c:manualLayout>
                  <c:x val="0.30826612660624292"/>
                  <c:y val="3.34248366013071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8834105898727302"/>
                      <c:h val="0.10415686274509804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19FC-4396-8BCF-77A4EEB2E7AC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남자_2015_I!$A$5:$A$14</c:f>
              <c:strCache>
                <c:ptCount val="10"/>
                <c:pt idx="0">
                  <c:v>Lung</c:v>
                </c:pt>
                <c:pt idx="1">
                  <c:v>Stomach</c:v>
                </c:pt>
                <c:pt idx="2">
                  <c:v>Colorectal</c:v>
                </c:pt>
                <c:pt idx="3">
                  <c:v>Liver</c:v>
                </c:pt>
                <c:pt idx="4">
                  <c:v>Bladder</c:v>
                </c:pt>
                <c:pt idx="5">
                  <c:v>Pancreas</c:v>
                </c:pt>
                <c:pt idx="6">
                  <c:v>Esophagus</c:v>
                </c:pt>
                <c:pt idx="7">
                  <c:v>Larynx</c:v>
                </c:pt>
                <c:pt idx="8">
                  <c:v>Oral cavity/Pharynx</c:v>
                </c:pt>
                <c:pt idx="9">
                  <c:v>Kidney</c:v>
                </c:pt>
              </c:strCache>
            </c:strRef>
          </c:cat>
          <c:val>
            <c:numRef>
              <c:f>남자_2015_I!$B$5:$B$14</c:f>
              <c:numCache>
                <c:formatCode>General</c:formatCode>
                <c:ptCount val="10"/>
                <c:pt idx="0">
                  <c:v>42.4</c:v>
                </c:pt>
                <c:pt idx="1">
                  <c:v>24.5</c:v>
                </c:pt>
                <c:pt idx="2">
                  <c:v>9.8000000000000007</c:v>
                </c:pt>
                <c:pt idx="3">
                  <c:v>9</c:v>
                </c:pt>
                <c:pt idx="4">
                  <c:v>4.3</c:v>
                </c:pt>
                <c:pt idx="5">
                  <c:v>2.9</c:v>
                </c:pt>
                <c:pt idx="6">
                  <c:v>2.2999999999999998</c:v>
                </c:pt>
                <c:pt idx="7">
                  <c:v>2.1</c:v>
                </c:pt>
                <c:pt idx="8">
                  <c:v>2</c:v>
                </c:pt>
                <c:pt idx="9">
                  <c:v>0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19FC-4396-8BCF-77A4EEB2E7AC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7CFB-4CF6-8A51-74B38B2A8853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7CFB-4CF6-8A51-74B38B2A8853}"/>
              </c:ext>
            </c:extLst>
          </c:dPt>
          <c:dLbls>
            <c:dLbl>
              <c:idx val="0"/>
              <c:layout>
                <c:manualLayout>
                  <c:x val="5.4630542865811878E-2"/>
                  <c:y val="-0.26685603564662963"/>
                </c:manualLayout>
              </c:layout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C7F8C69F-F259-4A6F-BA4A-79B10B4B7855}" type="CATEGORYNAM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endParaRPr lang="en-US" altLang="ko-KR"/>
                  </a:p>
                  <a:p>
                    <a:pPr>
                      <a:defRPr sz="700" spc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defRPr>
                    </a:pPr>
                    <a:fld id="{F3FC84EB-4EE9-4277-B0F1-8F2208921F4F}" type="PERCENTAGE">
                      <a:rPr lang="en-US" altLang="ko-KR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ko-KR" altLang="en-US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layout>
                    <c:manualLayout>
                      <c:w val="0.14579939953176202"/>
                      <c:h val="0.12980084840675871"/>
                    </c:manualLayout>
                  </c15:layout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7CFB-4CF6-8A51-74B38B2A8853}"/>
                </c:ext>
              </c:extLst>
            </c:dLbl>
            <c:dLbl>
              <c:idx val="1"/>
              <c:tx>
                <c:rich>
                  <a:bodyPr rot="0" spcFirstLastPara="1" vertOverflow="ellipsis" horzOverflow="clip" vert="horz" wrap="square" lIns="38100" tIns="19050" rIns="38100" bIns="19050" anchor="ctr" anchorCtr="1">
                    <a:no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FE9CDE63-E94A-464D-BFC0-F5BB1B4DABEC}" type="CATEGORYNAM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 </a:t>
                    </a:r>
                    <a:fld id="{28FCF578-7890-4DCD-84F5-5B7E3D09DAC3}" type="PERCENTAGE">
                      <a:rPr lang="en-US" altLang="ko-KR" baseline="0"/>
                      <a:pPr>
                        <a:defRPr sz="700" spc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백분율]</a:t>
                    </a:fld>
                    <a:endParaRPr lang="en-US" altLang="ko-KR" baseline="0"/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horzOverflow="clip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en-US" altLang="ko-KR"/>
                </a:p>
              </c:txPr>
              <c:dLblPos val="outEnd"/>
              <c:showLegendKey val="0"/>
              <c:showVal val="1"/>
              <c:showCatName val="1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pPr xmlns:c15="http://schemas.microsoft.com/office/drawing/2012/chart">
                    <a:prstGeom prst="rect">
                      <a:avLst/>
                    </a:prstGeom>
                    <a:noFill/>
                    <a:ln>
                      <a:noFill/>
                    </a:ln>
                  </c15:spPr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3-7CFB-4CF6-8A51-74B38B2A8853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15_I!$A$1:$A$2</c:f>
              <c:strCache>
                <c:ptCount val="2"/>
                <c:pt idx="0">
                  <c:v>Others</c:v>
                </c:pt>
                <c:pt idx="1">
                  <c:v>Smoking</c:v>
                </c:pt>
              </c:strCache>
            </c:strRef>
          </c:cat>
          <c:val>
            <c:numRef>
              <c:f>여자_2015_I!$B$1:$B$2</c:f>
              <c:numCache>
                <c:formatCode>General</c:formatCode>
                <c:ptCount val="2"/>
                <c:pt idx="0">
                  <c:v>98.5</c:v>
                </c:pt>
                <c:pt idx="1">
                  <c:v>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CFB-4CF6-8A51-74B38B2A8853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92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pieChart>
        <c:varyColors val="1"/>
        <c:ser>
          <c:idx val="0"/>
          <c:order val="0"/>
          <c:explosion val="1"/>
          <c:dPt>
            <c:idx val="0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3963-44DF-ADDC-2920C40A91A1}"/>
              </c:ext>
            </c:extLst>
          </c:dPt>
          <c:dPt>
            <c:idx val="1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3963-44DF-ADDC-2920C40A91A1}"/>
              </c:ext>
            </c:extLst>
          </c:dPt>
          <c:dPt>
            <c:idx val="2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3963-44DF-ADDC-2920C40A91A1}"/>
              </c:ext>
            </c:extLst>
          </c:dPt>
          <c:dPt>
            <c:idx val="3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3963-44DF-ADDC-2920C40A91A1}"/>
              </c:ext>
            </c:extLst>
          </c:dPt>
          <c:dPt>
            <c:idx val="4"/>
            <c:bubble3D val="0"/>
            <c:spPr>
              <a:solidFill>
                <a:schemeClr val="dk1">
                  <a:tint val="3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3963-44DF-ADDC-2920C40A91A1}"/>
              </c:ext>
            </c:extLst>
          </c:dPt>
          <c:dPt>
            <c:idx val="5"/>
            <c:bubble3D val="0"/>
            <c:spPr>
              <a:solidFill>
                <a:schemeClr val="dk1">
                  <a:tint val="6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3963-44DF-ADDC-2920C40A91A1}"/>
              </c:ext>
            </c:extLst>
          </c:dPt>
          <c:dPt>
            <c:idx val="6"/>
            <c:bubble3D val="0"/>
            <c:spPr>
              <a:solidFill>
                <a:schemeClr val="dk1">
                  <a:tint val="80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3963-44DF-ADDC-2920C40A91A1}"/>
              </c:ext>
            </c:extLst>
          </c:dPt>
          <c:dPt>
            <c:idx val="7"/>
            <c:bubble3D val="0"/>
            <c:spPr>
              <a:solidFill>
                <a:schemeClr val="dk1">
                  <a:tint val="8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3963-44DF-ADDC-2920C40A91A1}"/>
              </c:ext>
            </c:extLst>
          </c:dPt>
          <c:dPt>
            <c:idx val="8"/>
            <c:bubble3D val="0"/>
            <c:spPr>
              <a:solidFill>
                <a:schemeClr val="dk1">
                  <a:tint val="5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3963-44DF-ADDC-2920C40A91A1}"/>
              </c:ext>
            </c:extLst>
          </c:dPt>
          <c:dPt>
            <c:idx val="9"/>
            <c:bubble3D val="0"/>
            <c:spPr>
              <a:solidFill>
                <a:schemeClr val="dk1">
                  <a:tint val="750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3963-44DF-ADDC-2920C40A91A1}"/>
              </c:ext>
            </c:extLst>
          </c:dPt>
          <c:dPt>
            <c:idx val="10"/>
            <c:bubble3D val="0"/>
            <c:spPr>
              <a:solidFill>
                <a:schemeClr val="dk1">
                  <a:tint val="98500"/>
                </a:schemeClr>
              </a:solidFill>
              <a:ln>
                <a:noFill/>
              </a:ln>
              <a:effectLst>
                <a:outerShdw blurRad="635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3963-44DF-ADDC-2920C40A91A1}"/>
              </c:ext>
            </c:extLst>
          </c:dPt>
          <c:dLbls>
            <c:dLbl>
              <c:idx val="0"/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sz="700" b="1" i="0" u="none" strike="noStrike" kern="1200" spc="0" baseline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defRPr>
                    </a:pPr>
                    <a:fld id="{8638A74A-F646-4448-95F3-D35787435805}" type="CATEGORYNAME">
                      <a:rPr lang="en-US" altLang="ko-KR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범주 이름]</a:t>
                    </a:fld>
                    <a:r>
                      <a:rPr lang="en-US" altLang="ko-KR" baseline="0"/>
                      <a:t>
</a:t>
                    </a:r>
                    <a:fld id="{9A358069-5A98-4D36-8568-3DB055DCD609}" type="VALUE">
                      <a:rPr lang="en-US" altLang="ko-KR" baseline="0"/>
                      <a:pPr>
                        <a:defRPr sz="7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defRPr>
                      </a:pPr>
                      <a:t>[값]</a:t>
                    </a:fld>
                    <a:r>
                      <a:rPr lang="en-US" altLang="ko-KR" baseline="0"/>
                      <a:t>%</a:t>
                    </a:r>
                  </a:p>
                </c:rich>
              </c:tx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outEnd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1-3963-44DF-ADDC-2920C40A91A1}"/>
                </c:ext>
              </c:extLst>
            </c:dLbl>
            <c:dLbl>
              <c:idx val="1"/>
              <c:layout>
                <c:manualLayout>
                  <c:x val="-9.3976001453731209E-2"/>
                  <c:y val="-2.9526807034904259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3963-44DF-ADDC-2920C40A91A1}"/>
                </c:ext>
              </c:extLst>
            </c:dLbl>
            <c:dLbl>
              <c:idx val="2"/>
              <c:layout>
                <c:manualLayout>
                  <c:x val="0"/>
                  <c:y val="-1.557468598459148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3963-44DF-ADDC-2920C40A91A1}"/>
                </c:ext>
              </c:extLst>
            </c:dLbl>
            <c:dLbl>
              <c:idx val="3"/>
              <c:layout>
                <c:manualLayout>
                  <c:x val="7.8682278951758347E-3"/>
                  <c:y val="1.241153276898312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3963-44DF-ADDC-2920C40A91A1}"/>
                </c:ext>
              </c:extLst>
            </c:dLbl>
            <c:dLbl>
              <c:idx val="4"/>
              <c:layout>
                <c:manualLayout>
                  <c:x val="0"/>
                  <c:y val="-2.9635418249834072E-3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3963-44DF-ADDC-2920C40A91A1}"/>
                </c:ext>
              </c:extLst>
            </c:dLbl>
            <c:dLbl>
              <c:idx val="5"/>
              <c:layout>
                <c:manualLayout>
                  <c:x val="-1.390363439458818E-2"/>
                  <c:y val="-3.083919111421439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5037546873502955"/>
                      <c:h val="8.3308919457737482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B-3963-44DF-ADDC-2920C40A91A1}"/>
                </c:ext>
              </c:extLst>
            </c:dLbl>
            <c:dLbl>
              <c:idx val="6"/>
              <c:layout>
                <c:manualLayout>
                  <c:x val="-3.2658364512450924E-2"/>
                  <c:y val="-4.447418300653596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D-3963-44DF-ADDC-2920C40A91A1}"/>
                </c:ext>
              </c:extLst>
            </c:dLbl>
            <c:dLbl>
              <c:idx val="7"/>
              <c:layout>
                <c:manualLayout>
                  <c:x val="6.6738010877690213E-2"/>
                  <c:y val="-4.3286437908496733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6554452694276381"/>
                      <c:h val="8.9409734730599308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F-3963-44DF-ADDC-2920C40A91A1}"/>
                </c:ext>
              </c:extLst>
            </c:dLbl>
            <c:dLbl>
              <c:idx val="8"/>
              <c:layout>
                <c:manualLayout>
                  <c:x val="0.40442249795485835"/>
                  <c:y val="-2.912875816993464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29877604352141091"/>
                      <c:h val="8.4899673202614379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1-3963-44DF-ADDC-2920C40A91A1}"/>
                </c:ext>
              </c:extLst>
            </c:dLbl>
            <c:dLbl>
              <c:idx val="9"/>
              <c:layout>
                <c:manualLayout>
                  <c:x val="0.37825367210240551"/>
                  <c:y val="2.4428758169934631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no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6720737835151939"/>
                      <c:h val="8.3005882352941179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13-3963-44DF-ADDC-2920C40A91A1}"/>
                </c:ext>
              </c:extLst>
            </c:dLbl>
            <c:dLbl>
              <c:idx val="10"/>
              <c:layout>
                <c:manualLayout>
                  <c:x val="-4.4037938124567699E-3"/>
                  <c:y val="-2.1869934640522875E-2"/>
                </c:manualLayout>
              </c:layout>
              <c:numFmt formatCode="0.0%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700" b="1" i="0" u="none" strike="noStrike" kern="1200" spc="0" baseline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+mn-ea"/>
                      <a:cs typeface="Times New Roman" panose="02020603050405020304" pitchFamily="18" charset="0"/>
                    </a:defRPr>
                  </a:pPr>
                  <a:endParaRPr lang="ko-KR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5-3963-44DF-ADDC-2920C40A91A1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700" b="1" i="0" u="none" strike="noStrike" kern="1200" spc="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0"/>
            <c:showCatName val="1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여자_2015_I!$A$5:$A$15</c:f>
              <c:strCache>
                <c:ptCount val="11"/>
                <c:pt idx="0">
                  <c:v>Lung</c:v>
                </c:pt>
                <c:pt idx="1">
                  <c:v>Pancreas</c:v>
                </c:pt>
                <c:pt idx="2">
                  <c:v>Colorectal</c:v>
                </c:pt>
                <c:pt idx="3">
                  <c:v>Liver</c:v>
                </c:pt>
                <c:pt idx="4">
                  <c:v>Cervix uteri</c:v>
                </c:pt>
                <c:pt idx="5">
                  <c:v>Stomach</c:v>
                </c:pt>
                <c:pt idx="6">
                  <c:v>Bladder</c:v>
                </c:pt>
                <c:pt idx="7">
                  <c:v>Esophagus</c:v>
                </c:pt>
                <c:pt idx="8">
                  <c:v>Oral cavity/Pharynx</c:v>
                </c:pt>
                <c:pt idx="9">
                  <c:v>Larynx</c:v>
                </c:pt>
                <c:pt idx="10">
                  <c:v>Kidney</c:v>
                </c:pt>
              </c:strCache>
            </c:strRef>
          </c:cat>
          <c:val>
            <c:numRef>
              <c:f>여자_2015_I!$B$5:$B$15</c:f>
              <c:numCache>
                <c:formatCode>General</c:formatCode>
                <c:ptCount val="11"/>
                <c:pt idx="0">
                  <c:v>46.1</c:v>
                </c:pt>
                <c:pt idx="1">
                  <c:v>11.6</c:v>
                </c:pt>
                <c:pt idx="2">
                  <c:v>11.3</c:v>
                </c:pt>
                <c:pt idx="3">
                  <c:v>8.9</c:v>
                </c:pt>
                <c:pt idx="4">
                  <c:v>6.3</c:v>
                </c:pt>
                <c:pt idx="5">
                  <c:v>4.9000000000000004</c:v>
                </c:pt>
                <c:pt idx="6">
                  <c:v>3.2</c:v>
                </c:pt>
                <c:pt idx="7">
                  <c:v>2.6</c:v>
                </c:pt>
                <c:pt idx="8">
                  <c:v>2</c:v>
                </c:pt>
                <c:pt idx="9">
                  <c:v>1.9</c:v>
                </c:pt>
                <c:pt idx="10">
                  <c:v>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3963-44DF-ADDC-2920C40A91A1}"/>
            </c:ext>
          </c:extLst>
        </c:ser>
        <c:dLbls>
          <c:dLblPos val="outEnd"/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5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cs:styleClr val="auto"/>
    </cs:fontRef>
    <cs:defRPr sz="1000" b="1" i="0" u="none" strike="noStrike" kern="1200" spc="0" baseline="0"/>
  </cs:dataLabel>
  <cs:dataLabelCallout>
    <cs:lnRef idx="0">
      <cs:styleClr val="auto"/>
    </cs:lnRef>
    <cs:fillRef idx="0"/>
    <cs:effectRef idx="0"/>
    <cs:fontRef idx="minor">
      <cs:styleClr val="auto"/>
    </cs:fontRef>
    <cs:spPr>
      <a:solidFill>
        <a:schemeClr val="lt1"/>
      </a:solidFill>
      <a:ln>
        <a:solidFill>
          <a:schemeClr val="phClr"/>
        </a:solidFill>
      </a:ln>
    </cs:spPr>
    <cs:defRPr sz="1000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635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88900" sx="102000" sy="102000" algn="ctr" rotWithShape="0">
          <a:prstClr val="black">
            <a:alpha val="10000"/>
          </a:prstClr>
        </a:outerShdw>
      </a:effectLst>
      <a:scene3d>
        <a:camera prst="orthographicFront"/>
        <a:lightRig rig="threePt" dir="t"/>
      </a:scene3d>
      <a:sp3d>
        <a:bevelT w="127000" h="127000"/>
        <a:bevelB w="127000" h="127000"/>
      </a:sp3d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600" b="1" kern="1200" cap="all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5397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0712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9746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5050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159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4482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5682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7142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9130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7685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22209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D2311-79D7-4829-A2DA-EB0752485FF6}" type="datetimeFigureOut">
              <a:rPr lang="ko-KR" altLang="en-US" smtClean="0"/>
              <a:t>2025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29C3B8-F509-4492-8044-96780F08268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34086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>
            <a:extLst>
              <a:ext uri="{FF2B5EF4-FFF2-40B4-BE49-F238E27FC236}">
                <a16:creationId xmlns:a16="http://schemas.microsoft.com/office/drawing/2014/main" id="{9F1CB6AB-11E0-4300-9FAF-3A490E644276}"/>
              </a:ext>
            </a:extLst>
          </p:cNvPr>
          <p:cNvGrpSpPr/>
          <p:nvPr/>
        </p:nvGrpSpPr>
        <p:grpSpPr>
          <a:xfrm>
            <a:off x="515253" y="370642"/>
            <a:ext cx="5786853" cy="9295697"/>
            <a:chOff x="515253" y="609305"/>
            <a:chExt cx="5786853" cy="9295697"/>
          </a:xfrm>
        </p:grpSpPr>
        <p:grpSp>
          <p:nvGrpSpPr>
            <p:cNvPr id="26" name="그룹 25">
              <a:extLst>
                <a:ext uri="{FF2B5EF4-FFF2-40B4-BE49-F238E27FC236}">
                  <a16:creationId xmlns:a16="http://schemas.microsoft.com/office/drawing/2014/main" id="{E03DA8E3-4D3C-4175-AE94-F9C82514A279}"/>
                </a:ext>
              </a:extLst>
            </p:cNvPr>
            <p:cNvGrpSpPr/>
            <p:nvPr/>
          </p:nvGrpSpPr>
          <p:grpSpPr>
            <a:xfrm>
              <a:off x="515253" y="609305"/>
              <a:ext cx="5786853" cy="8878907"/>
              <a:chOff x="515253" y="666946"/>
              <a:chExt cx="5786853" cy="8969639"/>
            </a:xfrm>
          </p:grpSpPr>
          <p:grpSp>
            <p:nvGrpSpPr>
              <p:cNvPr id="23" name="그룹 22">
                <a:extLst>
                  <a:ext uri="{FF2B5EF4-FFF2-40B4-BE49-F238E27FC236}">
                    <a16:creationId xmlns:a16="http://schemas.microsoft.com/office/drawing/2014/main" id="{673F54C8-5FC1-4C50-8EF4-20D2E4C00776}"/>
                  </a:ext>
                </a:extLst>
              </p:cNvPr>
              <p:cNvGrpSpPr/>
              <p:nvPr/>
            </p:nvGrpSpPr>
            <p:grpSpPr>
              <a:xfrm>
                <a:off x="515253" y="666946"/>
                <a:ext cx="5761755" cy="3083140"/>
                <a:chOff x="515253" y="623271"/>
                <a:chExt cx="5761755" cy="3083140"/>
              </a:xfrm>
            </p:grpSpPr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ED0E3951-E7A8-4D37-953A-49C87951C1DC}"/>
                    </a:ext>
                  </a:extLst>
                </p:cNvPr>
                <p:cNvSpPr txBox="1"/>
                <p:nvPr/>
              </p:nvSpPr>
              <p:spPr>
                <a:xfrm>
                  <a:off x="515253" y="623271"/>
                  <a:ext cx="15055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otal cancer case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3" name="그룹 62">
                  <a:extLst>
                    <a:ext uri="{FF2B5EF4-FFF2-40B4-BE49-F238E27FC236}">
                      <a16:creationId xmlns:a16="http://schemas.microsoft.com/office/drawing/2014/main" id="{725D8E18-6B9A-4BD4-9BB9-741540969C58}"/>
                    </a:ext>
                  </a:extLst>
                </p:cNvPr>
                <p:cNvGrpSpPr/>
                <p:nvPr/>
              </p:nvGrpSpPr>
              <p:grpSpPr>
                <a:xfrm>
                  <a:off x="582396" y="646412"/>
                  <a:ext cx="5694612" cy="3059999"/>
                  <a:chOff x="0" y="87084"/>
                  <a:chExt cx="5694612" cy="3394724"/>
                </a:xfrm>
              </p:grpSpPr>
              <p:grpSp>
                <p:nvGrpSpPr>
                  <p:cNvPr id="64" name="그룹 63">
                    <a:extLst>
                      <a:ext uri="{FF2B5EF4-FFF2-40B4-BE49-F238E27FC236}">
                        <a16:creationId xmlns:a16="http://schemas.microsoft.com/office/drawing/2014/main" id="{EE5641A4-CD98-4B05-A516-70046BF5E45B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87084"/>
                    <a:ext cx="5694612" cy="3394724"/>
                    <a:chOff x="0" y="91826"/>
                    <a:chExt cx="6113259" cy="3579573"/>
                  </a:xfrm>
                </p:grpSpPr>
                <p:grpSp>
                  <p:nvGrpSpPr>
                    <p:cNvPr id="66" name="그룹 65">
                      <a:extLst>
                        <a:ext uri="{FF2B5EF4-FFF2-40B4-BE49-F238E27FC236}">
                          <a16:creationId xmlns:a16="http://schemas.microsoft.com/office/drawing/2014/main" id="{7AE5A462-5344-4401-A15C-24844D0F1C2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91826"/>
                      <a:ext cx="6113259" cy="3579573"/>
                      <a:chOff x="0" y="106172"/>
                      <a:chExt cx="11104343" cy="4138820"/>
                    </a:xfrm>
                  </p:grpSpPr>
                  <p:graphicFrame>
                    <p:nvGraphicFramePr>
                      <p:cNvPr id="69" name="차트 68">
                        <a:extLst>
                          <a:ext uri="{FF2B5EF4-FFF2-40B4-BE49-F238E27FC236}">
                            <a16:creationId xmlns:a16="http://schemas.microsoft.com/office/drawing/2014/main" id="{07E25AEA-E968-4102-8C18-B414DC6D197F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5272434" y="106172"/>
                      <a:ext cx="5831909" cy="4138820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2"/>
                      </a:graphicData>
                    </a:graphic>
                  </p:graphicFrame>
                  <p:graphicFrame>
                    <p:nvGraphicFramePr>
                      <p:cNvPr id="68" name="차트 67">
                        <a:extLst>
                          <a:ext uri="{FF2B5EF4-FFF2-40B4-BE49-F238E27FC236}">
                            <a16:creationId xmlns:a16="http://schemas.microsoft.com/office/drawing/2014/main" id="{1BAEE53E-7695-4444-9915-6EEC371E51F1}"/>
                          </a:ext>
                        </a:extLst>
                      </p:cNvPr>
                      <p:cNvGraphicFramePr>
                        <a:graphicFrameLocks/>
                      </p:cNvGraphicFramePr>
                      <p:nvPr/>
                    </p:nvGraphicFramePr>
                    <p:xfrm>
                      <a:off x="0" y="652478"/>
                      <a:ext cx="4681538" cy="2833864"/>
                    </p:xfrm>
                    <a:graphic>
                      <a:graphicData uri="http://schemas.openxmlformats.org/drawingml/2006/chart">
                        <c:chart xmlns:c="http://schemas.openxmlformats.org/drawingml/2006/chart" xmlns:r="http://schemas.openxmlformats.org/officeDocument/2006/relationships" r:id="rId3"/>
                      </a:graphicData>
                    </a:graphic>
                  </p:graphicFrame>
                </p:grpSp>
                <p:cxnSp>
                  <p:nvCxnSpPr>
                    <p:cNvPr id="67" name="직선 연결선 66">
                      <a:extLst>
                        <a:ext uri="{FF2B5EF4-FFF2-40B4-BE49-F238E27FC236}">
                          <a16:creationId xmlns:a16="http://schemas.microsoft.com/office/drawing/2014/main" id="{0315F8D5-4753-4FED-BCB5-8F010B638945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2154791" y="2218786"/>
                      <a:ext cx="1980692" cy="1023525"/>
                    </a:xfrm>
                    <a:prstGeom prst="line">
                      <a:avLst/>
                    </a:prstGeom>
                    <a:ln>
                      <a:solidFill>
                        <a:schemeClr val="accent3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65" name="직선 연결선 64">
                    <a:extLst>
                      <a:ext uri="{FF2B5EF4-FFF2-40B4-BE49-F238E27FC236}">
                        <a16:creationId xmlns:a16="http://schemas.microsoft.com/office/drawing/2014/main" id="{E8144AE7-76CE-4813-BB72-AA6155E46AA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02972" y="471190"/>
                    <a:ext cx="1912085" cy="831186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3" name="그룹 2">
                <a:extLst>
                  <a:ext uri="{FF2B5EF4-FFF2-40B4-BE49-F238E27FC236}">
                    <a16:creationId xmlns:a16="http://schemas.microsoft.com/office/drawing/2014/main" id="{F7638D37-A8A6-494F-8658-E601A38B18A6}"/>
                  </a:ext>
                </a:extLst>
              </p:cNvPr>
              <p:cNvGrpSpPr/>
              <p:nvPr/>
            </p:nvGrpSpPr>
            <p:grpSpPr>
              <a:xfrm>
                <a:off x="515253" y="3637379"/>
                <a:ext cx="5762257" cy="3126336"/>
                <a:chOff x="515253" y="3510136"/>
                <a:chExt cx="5762257" cy="3126336"/>
              </a:xfrm>
            </p:grpSpPr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258A911A-63B4-40A6-978C-8464EFBD17F1}"/>
                    </a:ext>
                  </a:extLst>
                </p:cNvPr>
                <p:cNvSpPr txBox="1"/>
                <p:nvPr/>
              </p:nvSpPr>
              <p:spPr>
                <a:xfrm>
                  <a:off x="515253" y="3510136"/>
                  <a:ext cx="1492716" cy="2487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ale cancer case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70" name="그룹 69">
                  <a:extLst>
                    <a:ext uri="{FF2B5EF4-FFF2-40B4-BE49-F238E27FC236}">
                      <a16:creationId xmlns:a16="http://schemas.microsoft.com/office/drawing/2014/main" id="{629BEDEC-4D18-48CC-8EDE-20C7E3B2CC57}"/>
                    </a:ext>
                  </a:extLst>
                </p:cNvPr>
                <p:cNvGrpSpPr/>
                <p:nvPr/>
              </p:nvGrpSpPr>
              <p:grpSpPr>
                <a:xfrm>
                  <a:off x="580488" y="3576472"/>
                  <a:ext cx="5697022" cy="3060000"/>
                  <a:chOff x="0" y="0"/>
                  <a:chExt cx="5695117" cy="3251851"/>
                </a:xfrm>
              </p:grpSpPr>
              <p:grpSp>
                <p:nvGrpSpPr>
                  <p:cNvPr id="71" name="그룹 70">
                    <a:extLst>
                      <a:ext uri="{FF2B5EF4-FFF2-40B4-BE49-F238E27FC236}">
                        <a16:creationId xmlns:a16="http://schemas.microsoft.com/office/drawing/2014/main" id="{104183AF-7F52-494B-A2BA-5A871E0BD761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695117" cy="3251851"/>
                    <a:chOff x="0" y="0"/>
                    <a:chExt cx="11105324" cy="4138820"/>
                  </a:xfrm>
                </p:grpSpPr>
                <p:graphicFrame>
                  <p:nvGraphicFramePr>
                    <p:cNvPr id="74" name="차트 73">
                      <a:extLst>
                        <a:ext uri="{FF2B5EF4-FFF2-40B4-BE49-F238E27FC236}">
                          <a16:creationId xmlns:a16="http://schemas.microsoft.com/office/drawing/2014/main" id="{6612F8D1-8712-4193-A55E-538943254BBA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0" y="652478"/>
                    <a:ext cx="4681538" cy="2833864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4"/>
                    </a:graphicData>
                  </a:graphic>
                </p:graphicFrame>
                <p:graphicFrame>
                  <p:nvGraphicFramePr>
                    <p:cNvPr id="75" name="차트 74">
                      <a:extLst>
                        <a:ext uri="{FF2B5EF4-FFF2-40B4-BE49-F238E27FC236}">
                          <a16:creationId xmlns:a16="http://schemas.microsoft.com/office/drawing/2014/main" id="{507CF691-064A-4100-A54D-3B03AD2A6C63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5273414" y="0"/>
                    <a:ext cx="5831910" cy="413882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5"/>
                    </a:graphicData>
                  </a:graphic>
                </p:graphicFrame>
              </p:grpSp>
              <p:cxnSp>
                <p:nvCxnSpPr>
                  <p:cNvPr id="72" name="직선 연결선 71">
                    <a:extLst>
                      <a:ext uri="{FF2B5EF4-FFF2-40B4-BE49-F238E27FC236}">
                        <a16:creationId xmlns:a16="http://schemas.microsoft.com/office/drawing/2014/main" id="{59E89D66-955A-4501-8469-D6F799AEE6F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841220" y="2277871"/>
                    <a:ext cx="1995792" cy="551712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3" name="직선 연결선 72">
                    <a:extLst>
                      <a:ext uri="{FF2B5EF4-FFF2-40B4-BE49-F238E27FC236}">
                        <a16:creationId xmlns:a16="http://schemas.microsoft.com/office/drawing/2014/main" id="{AD3B8072-300D-4C29-9B5A-A0B0EB237B6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1841220" y="389484"/>
                    <a:ext cx="1995792" cy="594632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2" name="그룹 1">
                <a:extLst>
                  <a:ext uri="{FF2B5EF4-FFF2-40B4-BE49-F238E27FC236}">
                    <a16:creationId xmlns:a16="http://schemas.microsoft.com/office/drawing/2014/main" id="{4D63DF6D-A459-4427-A286-0155E875BCDE}"/>
                  </a:ext>
                </a:extLst>
              </p:cNvPr>
              <p:cNvGrpSpPr/>
              <p:nvPr/>
            </p:nvGrpSpPr>
            <p:grpSpPr>
              <a:xfrm>
                <a:off x="515253" y="6576586"/>
                <a:ext cx="5786853" cy="3059999"/>
                <a:chOff x="515253" y="6617784"/>
                <a:chExt cx="5786853" cy="3059999"/>
              </a:xfrm>
            </p:grpSpPr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1CCE139B-33F4-42FE-852F-5255F617D6FF}"/>
                    </a:ext>
                  </a:extLst>
                </p:cNvPr>
                <p:cNvSpPr txBox="1"/>
                <p:nvPr/>
              </p:nvSpPr>
              <p:spPr>
                <a:xfrm>
                  <a:off x="515253" y="6698252"/>
                  <a:ext cx="1614545" cy="24873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0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Female cancer cases, 2015</a:t>
                  </a:r>
                  <a:endParaRPr lang="ko-KR" alt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76" name="그룹 75">
                  <a:extLst>
                    <a:ext uri="{FF2B5EF4-FFF2-40B4-BE49-F238E27FC236}">
                      <a16:creationId xmlns:a16="http://schemas.microsoft.com/office/drawing/2014/main" id="{8DD1DFE2-402A-47A2-8374-F5FB794FAB80}"/>
                    </a:ext>
                  </a:extLst>
                </p:cNvPr>
                <p:cNvGrpSpPr/>
                <p:nvPr/>
              </p:nvGrpSpPr>
              <p:grpSpPr>
                <a:xfrm>
                  <a:off x="580488" y="6617784"/>
                  <a:ext cx="5721618" cy="3059999"/>
                  <a:chOff x="0" y="0"/>
                  <a:chExt cx="5708366" cy="3214577"/>
                </a:xfrm>
              </p:grpSpPr>
              <p:grpSp>
                <p:nvGrpSpPr>
                  <p:cNvPr id="77" name="그룹 76">
                    <a:extLst>
                      <a:ext uri="{FF2B5EF4-FFF2-40B4-BE49-F238E27FC236}">
                        <a16:creationId xmlns:a16="http://schemas.microsoft.com/office/drawing/2014/main" id="{A1B69078-F02F-42D1-8A53-AA74F7FF2FE8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5708366" cy="3214577"/>
                    <a:chOff x="0" y="0"/>
                    <a:chExt cx="11105320" cy="4138820"/>
                  </a:xfrm>
                </p:grpSpPr>
                <p:graphicFrame>
                  <p:nvGraphicFramePr>
                    <p:cNvPr id="80" name="차트 79">
                      <a:extLst>
                        <a:ext uri="{FF2B5EF4-FFF2-40B4-BE49-F238E27FC236}">
                          <a16:creationId xmlns:a16="http://schemas.microsoft.com/office/drawing/2014/main" id="{873A6288-1E6D-4683-871E-D6701A847925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0" y="652478"/>
                    <a:ext cx="4681538" cy="2833864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6"/>
                    </a:graphicData>
                  </a:graphic>
                </p:graphicFrame>
                <p:graphicFrame>
                  <p:nvGraphicFramePr>
                    <p:cNvPr id="81" name="차트 80">
                      <a:extLst>
                        <a:ext uri="{FF2B5EF4-FFF2-40B4-BE49-F238E27FC236}">
                          <a16:creationId xmlns:a16="http://schemas.microsoft.com/office/drawing/2014/main" id="{84EB974B-380A-4123-89FF-3EC1802FE975}"/>
                        </a:ext>
                      </a:extLst>
                    </p:cNvPr>
                    <p:cNvGraphicFramePr>
                      <a:graphicFrameLocks/>
                    </p:cNvGraphicFramePr>
                    <p:nvPr/>
                  </p:nvGraphicFramePr>
                  <p:xfrm>
                    <a:off x="5273412" y="0"/>
                    <a:ext cx="5831908" cy="4138820"/>
                  </p:xfrm>
                  <a:graphic>
                    <a:graphicData uri="http://schemas.openxmlformats.org/drawingml/2006/chart">
                      <c:chart xmlns:c="http://schemas.openxmlformats.org/drawingml/2006/chart" xmlns:r="http://schemas.openxmlformats.org/officeDocument/2006/relationships" r:id="rId7"/>
                    </a:graphicData>
                  </a:graphic>
                </p:graphicFrame>
              </p:grpSp>
              <p:cxnSp>
                <p:nvCxnSpPr>
                  <p:cNvPr id="78" name="직선 연결선 77">
                    <a:extLst>
                      <a:ext uri="{FF2B5EF4-FFF2-40B4-BE49-F238E27FC236}">
                        <a16:creationId xmlns:a16="http://schemas.microsoft.com/office/drawing/2014/main" id="{D065E644-59BA-4ED3-8CE6-9FAAF748E17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055740" y="343192"/>
                    <a:ext cx="1789520" cy="1150164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9" name="직선 연결선 78">
                    <a:extLst>
                      <a:ext uri="{FF2B5EF4-FFF2-40B4-BE49-F238E27FC236}">
                        <a16:creationId xmlns:a16="http://schemas.microsoft.com/office/drawing/2014/main" id="{DB293F46-D926-4EA0-9AC4-2B82929900D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059053" y="1714203"/>
                    <a:ext cx="1763565" cy="1126994"/>
                  </a:xfrm>
                  <a:prstGeom prst="line">
                    <a:avLst/>
                  </a:prstGeom>
                  <a:ln>
                    <a:solidFill>
                      <a:schemeClr val="accent3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53" name="직사각형 52">
              <a:extLst>
                <a:ext uri="{FF2B5EF4-FFF2-40B4-BE49-F238E27FC236}">
                  <a16:creationId xmlns:a16="http://schemas.microsoft.com/office/drawing/2014/main" id="{E9FFEC05-C143-45B5-A6AA-E9F7914DFFBF}"/>
                </a:ext>
              </a:extLst>
            </p:cNvPr>
            <p:cNvSpPr/>
            <p:nvPr/>
          </p:nvSpPr>
          <p:spPr>
            <a:xfrm>
              <a:off x="593479" y="9351004"/>
              <a:ext cx="5630400" cy="55399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ry Material 9. The population attributable fraction (%) of cancer cases attributed to tobacco smoking and proportion of specific cancers among all-cancer cases caused by tobacco smoking in Korea, 2015.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74363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</TotalTime>
  <Words>159</Words>
  <Application>Microsoft Office PowerPoint</Application>
  <PresentationFormat>A4 용지(210x297mm)</PresentationFormat>
  <Paragraphs>4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seul Sung</dc:creator>
  <cp:lastModifiedBy>이제인</cp:lastModifiedBy>
  <cp:revision>15</cp:revision>
  <dcterms:created xsi:type="dcterms:W3CDTF">2024-07-22T05:46:04Z</dcterms:created>
  <dcterms:modified xsi:type="dcterms:W3CDTF">2025-09-26T00:05:35Z</dcterms:modified>
</cp:coreProperties>
</file>